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1318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787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2033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3160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9214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2575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3789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357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1181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0118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0574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F5AD76-5014-4634-9DF9-425514B0661F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A2D52-A37A-4B8F-8DA7-B06C538BD8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8709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472333" y="5305696"/>
            <a:ext cx="711628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electronic expression profile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dCER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in different leaves. Mature leaves come from 47d plants, other leaves come from 23d plants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7898" y="526432"/>
            <a:ext cx="7071360" cy="4779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4410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P R 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Windows User</cp:lastModifiedBy>
  <cp:revision>2</cp:revision>
  <dcterms:created xsi:type="dcterms:W3CDTF">2019-02-22T04:13:57Z</dcterms:created>
  <dcterms:modified xsi:type="dcterms:W3CDTF">2019-02-22T04:16:55Z</dcterms:modified>
</cp:coreProperties>
</file>